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735763" cy="9866313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9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2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276" y="84"/>
      </p:cViewPr>
      <p:guideLst>
        <p:guide orient="horz" pos="3097"/>
        <p:guide pos="9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6F0E7-FD15-4EE7-BE7E-B91504887E1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5C57E6-2FC1-4B7F-A9C1-B7C3BF2B536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06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7C0C4-86BD-44AA-BA48-532F3CE388A5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560C63-0E5F-4F79-9E19-8EDA44005DC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421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7B5FDA-F372-48DD-8C3C-370C9015FCF9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489A9E-3EB9-4DB6-87D4-E740B71B8816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99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C0D9D5-3A67-4F9A-B958-5F084B9A1776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4AF34-1DC5-4FAE-A874-2AFC6626EFC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2877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361E0F-CBB6-4295-BEF5-8D6CEFAAD7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64C392-1ABB-401C-9E09-E0F4E77A4BA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22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9371B6-4E15-474F-BEF5-8DF1A0CC3F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7DBF49-C2EE-4243-9DDA-ECACE02EE4F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529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D3B6B8-3310-42C8-9503-82E0DD06A17C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2C61DC-EF6C-42CF-A95F-5EA824D88A5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682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E2FFB8-10C3-4DDC-BFB1-F5DA96EF200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B3A4582-A24B-43AE-8848-B28F27B1CA3D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86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840C8-D884-4585-AE4B-8A84B519972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17750D-E422-4FA2-8A8E-9F144631D8F0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82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DEA246-8415-4F73-B506-4EF236446FB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9242D4-7F37-4765-8228-AFFD464C80C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43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1402F-2B5F-41A6-A9E1-308A4E1683E7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AACC69-91FE-4395-AD7C-3667926C054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9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altLang="ko-KR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altLang="ko-KR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E52F96B-E043-4EF3-850C-A79CC90021C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900">
                <a:solidFill>
                  <a:srgbClr val="898989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</a:lstStyle>
          <a:p>
            <a:fld id="{C31CD9A6-5F9B-407A-AD78-81B512AE21E6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2pPr>
      <a:lvl3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3pPr>
      <a:lvl4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4pPr>
      <a:lvl5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5pPr>
      <a:lvl6pPr marL="4572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6pPr>
      <a:lvl7pPr marL="9144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7pPr>
      <a:lvl8pPr marL="13716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8pPr>
      <a:lvl9pPr marL="18288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9pPr>
    </p:titleStyle>
    <p:bodyStyle>
      <a:lvl1pPr marL="171450" indent="-171450" algn="l" defTabSz="685800" rtl="0" eaLnBrk="0" fontAlgn="base" latinLnBrk="1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그룹 21"/>
          <p:cNvGrpSpPr/>
          <p:nvPr/>
        </p:nvGrpSpPr>
        <p:grpSpPr>
          <a:xfrm>
            <a:off x="516852" y="805986"/>
            <a:ext cx="5934350" cy="6362943"/>
            <a:chOff x="516852" y="805986"/>
            <a:chExt cx="5934350" cy="6362943"/>
          </a:xfrm>
        </p:grpSpPr>
        <p:sp>
          <p:nvSpPr>
            <p:cNvPr id="18" name="TextBox 17"/>
            <p:cNvSpPr txBox="1"/>
            <p:nvPr/>
          </p:nvSpPr>
          <p:spPr>
            <a:xfrm>
              <a:off x="556370" y="1541940"/>
              <a:ext cx="1069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bronectin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5" name="개체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8376834"/>
                </p:ext>
              </p:extLst>
            </p:nvPr>
          </p:nvGraphicFramePr>
          <p:xfrm>
            <a:off x="1727325" y="1485811"/>
            <a:ext cx="4121086" cy="3949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3" name="Image" r:id="rId3" imgW="2485440" imgH="304560" progId="Photoshop.Image.13">
                    <p:embed/>
                  </p:oleObj>
                </mc:Choice>
                <mc:Fallback>
                  <p:oleObj name="Image" r:id="rId3" imgW="2485440" imgH="30456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>
                          <a:lum bright="-20000" contrast="4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27325" y="1485811"/>
                          <a:ext cx="4121086" cy="394964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" name="개체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2109078"/>
                </p:ext>
              </p:extLst>
            </p:nvPr>
          </p:nvGraphicFramePr>
          <p:xfrm>
            <a:off x="1749883" y="4243797"/>
            <a:ext cx="4121086" cy="3517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4" name="Image" r:id="rId5" imgW="6031440" imgH="367920" progId="Photoshop.Image.13">
                    <p:embed/>
                  </p:oleObj>
                </mc:Choice>
                <mc:Fallback>
                  <p:oleObj name="Image" r:id="rId5" imgW="6031440" imgH="36792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>
                          <a:lum bright="-20000" contrast="2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49883" y="4243797"/>
                          <a:ext cx="4121086" cy="35179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842262" y="4243797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smtClean="0">
                  <a:latin typeface="Arial" panose="020B0604020202020204" pitchFamily="34" charset="0"/>
                  <a:cs typeface="Arial" panose="020B0604020202020204" pitchFamily="34" charset="0"/>
                </a:rPr>
                <a:t>TGF</a:t>
              </a:r>
              <a:r>
                <a:rPr lang="el-GR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직선 연결선 4"/>
            <p:cNvCxnSpPr/>
            <p:nvPr/>
          </p:nvCxnSpPr>
          <p:spPr>
            <a:xfrm>
              <a:off x="1863275" y="5593916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직선 연결선 5"/>
            <p:cNvCxnSpPr/>
            <p:nvPr/>
          </p:nvCxnSpPr>
          <p:spPr>
            <a:xfrm>
              <a:off x="2833950" y="5593916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직선 연결선 6"/>
            <p:cNvCxnSpPr/>
            <p:nvPr/>
          </p:nvCxnSpPr>
          <p:spPr>
            <a:xfrm>
              <a:off x="3850966" y="5593916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4867982" y="5593916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1859611" y="5640715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WT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881707" y="5641731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KO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62858" y="5651891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WT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884954" y="5628523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KO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4" name="개체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77172395"/>
                </p:ext>
              </p:extLst>
            </p:nvPr>
          </p:nvGraphicFramePr>
          <p:xfrm>
            <a:off x="1749883" y="4720058"/>
            <a:ext cx="4121086" cy="3518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5" name="Image" r:id="rId7" imgW="6374520" imgH="736200" progId="Photoshop.Image.13">
                    <p:embed/>
                  </p:oleObj>
                </mc:Choice>
                <mc:Fallback>
                  <p:oleObj name="Image" r:id="rId7" imgW="6374520" imgH="7362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>
                          <a:lum contrast="2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49883" y="4720058"/>
                          <a:ext cx="4121086" cy="351814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개체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12178706"/>
                </p:ext>
              </p:extLst>
            </p:nvPr>
          </p:nvGraphicFramePr>
          <p:xfrm>
            <a:off x="1749883" y="5178921"/>
            <a:ext cx="4121086" cy="3020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6" name="Image" r:id="rId9" imgW="5815800" imgH="533160" progId="Photoshop.Image.13">
                    <p:embed/>
                  </p:oleObj>
                </mc:Choice>
                <mc:Fallback>
                  <p:oleObj name="Image" r:id="rId9" imgW="5815800" imgH="53316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>
                          <a:lum bright="-20000" contrast="4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49883" y="5178921"/>
                          <a:ext cx="4121086" cy="30209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904022" y="4720058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22882" y="5178921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0" name="개체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2326775"/>
                </p:ext>
              </p:extLst>
            </p:nvPr>
          </p:nvGraphicFramePr>
          <p:xfrm>
            <a:off x="1749883" y="3759191"/>
            <a:ext cx="4121086" cy="3601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7" name="Image" r:id="rId11" imgW="5536440" imgH="622080" progId="Photoshop.Image.13">
                    <p:embed/>
                  </p:oleObj>
                </mc:Choice>
                <mc:Fallback>
                  <p:oleObj name="Image" r:id="rId11" imgW="5536440" imgH="62208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>
                          <a:lum contrast="4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49883" y="3759191"/>
                          <a:ext cx="4121086" cy="360135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Box 20"/>
            <p:cNvSpPr txBox="1"/>
            <p:nvPr/>
          </p:nvSpPr>
          <p:spPr>
            <a:xfrm>
              <a:off x="516852" y="3767536"/>
              <a:ext cx="1069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bronectin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직선 연결선 25"/>
            <p:cNvCxnSpPr/>
            <p:nvPr/>
          </p:nvCxnSpPr>
          <p:spPr>
            <a:xfrm>
              <a:off x="1817749" y="3623394"/>
              <a:ext cx="188873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2482233" y="3260933"/>
              <a:ext cx="5597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직선 연결선 27"/>
            <p:cNvCxnSpPr/>
            <p:nvPr/>
          </p:nvCxnSpPr>
          <p:spPr>
            <a:xfrm>
              <a:off x="3820996" y="3619152"/>
              <a:ext cx="188873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485480" y="3256691"/>
              <a:ext cx="5389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07"/>
            <p:cNvSpPr>
              <a:spLocks noChangeArrowheads="1"/>
            </p:cNvSpPr>
            <p:nvPr/>
          </p:nvSpPr>
          <p:spPr bwMode="auto">
            <a:xfrm>
              <a:off x="885949" y="805986"/>
              <a:ext cx="350838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/>
              <a:r>
                <a:rPr kumimoji="0" lang="en-US" altLang="en-US" dirty="0">
                  <a:latin typeface="Arial" panose="020B0604020202020204" pitchFamily="34" charset="0"/>
                  <a:ea typeface="맑은 고딕" panose="020B0503020000020004" pitchFamily="50" charset="-127"/>
                </a:rPr>
                <a:t>A</a:t>
              </a:r>
            </a:p>
          </p:txBody>
        </p:sp>
        <p:cxnSp>
          <p:nvCxnSpPr>
            <p:cNvPr id="32" name="직선 연결선 31"/>
            <p:cNvCxnSpPr/>
            <p:nvPr/>
          </p:nvCxnSpPr>
          <p:spPr>
            <a:xfrm>
              <a:off x="1840362" y="1389489"/>
              <a:ext cx="188873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2504846" y="1027028"/>
              <a:ext cx="5597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직선 연결선 33"/>
            <p:cNvCxnSpPr/>
            <p:nvPr/>
          </p:nvCxnSpPr>
          <p:spPr>
            <a:xfrm>
              <a:off x="3843609" y="1385247"/>
              <a:ext cx="188873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4508093" y="1022786"/>
              <a:ext cx="5389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007"/>
            <p:cNvSpPr>
              <a:spLocks noChangeArrowheads="1"/>
            </p:cNvSpPr>
            <p:nvPr/>
          </p:nvSpPr>
          <p:spPr bwMode="auto">
            <a:xfrm>
              <a:off x="880433" y="2928853"/>
              <a:ext cx="338554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/>
              <a:r>
                <a:rPr kumimoji="0" lang="en-US" altLang="en-US" dirty="0" smtClean="0">
                  <a:latin typeface="Arial" panose="020B0604020202020204" pitchFamily="34" charset="0"/>
                  <a:ea typeface="맑은 고딕" panose="020B0503020000020004" pitchFamily="50" charset="-127"/>
                </a:rPr>
                <a:t>B</a:t>
              </a:r>
              <a:endParaRPr kumimoji="0" lang="en-US" altLang="en-US" dirty="0">
                <a:latin typeface="Arial" panose="020B0604020202020204" pitchFamily="34" charset="0"/>
                <a:ea typeface="맑은 고딕" panose="020B0503020000020004" pitchFamily="50" charset="-127"/>
              </a:endParaRPr>
            </a:p>
          </p:txBody>
        </p:sp>
        <p:sp>
          <p:nvSpPr>
            <p:cNvPr id="37" name="직사각형 36"/>
            <p:cNvSpPr/>
            <p:nvPr/>
          </p:nvSpPr>
          <p:spPr>
            <a:xfrm>
              <a:off x="592946" y="6399488"/>
              <a:ext cx="5858256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ko-KR" sz="1100" b="1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S3 Fig. Expression of </a:t>
              </a:r>
              <a:r>
                <a:rPr lang="en-US" altLang="ko-KR" sz="1100" b="1" kern="100" dirty="0" err="1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fibrogenetic</a:t>
              </a:r>
              <a:r>
                <a:rPr lang="en-US" altLang="ko-KR" sz="1100" b="1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 factors in ISO-treated CD38 wild type (WT) and CD38 knockout (KO) mice heart. </a:t>
              </a:r>
              <a:r>
                <a:rPr lang="en-US" altLang="ko-KR" sz="1100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(A) mRNA level of fibronectin and TGF</a:t>
              </a:r>
              <a:r>
                <a:rPr lang="el-GR" altLang="ko-KR" sz="1100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β</a:t>
              </a:r>
              <a:r>
                <a:rPr lang="en-US" altLang="ko-KR" sz="1100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1 (B) protein expression level of fibronectin and TGF</a:t>
              </a:r>
              <a:r>
                <a:rPr lang="el-GR" altLang="ko-KR" sz="1100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β</a:t>
              </a:r>
              <a:r>
                <a:rPr lang="en-US" altLang="ko-KR" sz="1100" kern="100" dirty="0" smtClean="0">
                  <a:latin typeface="Times New Roman" panose="02020603050405020304" pitchFamily="18" charset="0"/>
                  <a:ea typeface="바탕체" panose="02030609000101010101" pitchFamily="17" charset="-127"/>
                </a:rPr>
                <a:t>1. Heart were isolated and analyzed for protein expression </a:t>
              </a:r>
              <a:r>
                <a:rPr lang="en-US" altLang="ko-KR" sz="1100" kern="100" dirty="0">
                  <a:latin typeface="Times New Roman" panose="02020603050405020304" pitchFamily="18" charset="0"/>
                  <a:ea typeface="바탕체" panose="02030609000101010101" pitchFamily="17" charset="-127"/>
                </a:rPr>
                <a:t>before (Con) and following 7 days of ISO infusion (ISO).</a:t>
              </a:r>
              <a:endParaRPr lang="ko-KR" altLang="ko-KR" sz="1100" kern="1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endParaRPr>
            </a:p>
          </p:txBody>
        </p:sp>
        <p:graphicFrame>
          <p:nvGraphicFramePr>
            <p:cNvPr id="13" name="개체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56547853"/>
                </p:ext>
              </p:extLst>
            </p:nvPr>
          </p:nvGraphicFramePr>
          <p:xfrm>
            <a:off x="1725499" y="2313540"/>
            <a:ext cx="4121086" cy="3889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8" name="Image" r:id="rId13" imgW="2666520" imgH="545760" progId="Photoshop.Image.13">
                    <p:embed/>
                  </p:oleObj>
                </mc:Choice>
                <mc:Fallback>
                  <p:oleObj name="Image" r:id="rId13" imgW="2666520" imgH="54576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>
                          <a:lum contrast="4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25499" y="2313540"/>
                          <a:ext cx="4121086" cy="388951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TextBox 37"/>
            <p:cNvSpPr txBox="1"/>
            <p:nvPr/>
          </p:nvSpPr>
          <p:spPr>
            <a:xfrm>
              <a:off x="806854" y="2347511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9" name="개체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278010"/>
                </p:ext>
              </p:extLst>
            </p:nvPr>
          </p:nvGraphicFramePr>
          <p:xfrm>
            <a:off x="1725499" y="1914008"/>
            <a:ext cx="4122912" cy="3643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59" name="Image" r:id="rId15" imgW="2628360" imgH="228240" progId="Photoshop.Image.13">
                    <p:embed/>
                  </p:oleObj>
                </mc:Choice>
                <mc:Fallback>
                  <p:oleObj name="Image" r:id="rId15" imgW="2628360" imgH="22824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>
                          <a:lum bright="20000" contrast="4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725499" y="1914008"/>
                          <a:ext cx="4122912" cy="364364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/>
            <p:cNvSpPr txBox="1"/>
            <p:nvPr/>
          </p:nvSpPr>
          <p:spPr>
            <a:xfrm>
              <a:off x="881780" y="1930504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smtClean="0">
                  <a:latin typeface="Arial" panose="020B0604020202020204" pitchFamily="34" charset="0"/>
                  <a:cs typeface="Arial" panose="020B0604020202020204" pitchFamily="34" charset="0"/>
                </a:rPr>
                <a:t>TGF</a:t>
              </a:r>
              <a:r>
                <a:rPr lang="el-GR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직선 연결선 39"/>
            <p:cNvCxnSpPr/>
            <p:nvPr/>
          </p:nvCxnSpPr>
          <p:spPr>
            <a:xfrm>
              <a:off x="1844026" y="2801044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>
            <a:xfrm>
              <a:off x="2814701" y="2801044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직선 연결선 41"/>
            <p:cNvCxnSpPr/>
            <p:nvPr/>
          </p:nvCxnSpPr>
          <p:spPr>
            <a:xfrm>
              <a:off x="3831717" y="2801044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직선 연결선 42"/>
            <p:cNvCxnSpPr/>
            <p:nvPr/>
          </p:nvCxnSpPr>
          <p:spPr>
            <a:xfrm>
              <a:off x="4848733" y="2801044"/>
              <a:ext cx="9144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1840362" y="2847843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WT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862458" y="2848859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KO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843609" y="2859019"/>
              <a:ext cx="8595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WT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865705" y="2835651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8 KO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48018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6</TotalTime>
  <Words>103</Words>
  <Application>Microsoft Office PowerPoint</Application>
  <PresentationFormat>A4 용지(210x297mm)</PresentationFormat>
  <Paragraphs>22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10" baseType="lpstr">
      <vt:lpstr>굴림</vt:lpstr>
      <vt:lpstr>맑은 고딕</vt:lpstr>
      <vt:lpstr>바탕체</vt:lpstr>
      <vt:lpstr>Arial</vt:lpstr>
      <vt:lpstr>Calibri</vt:lpstr>
      <vt:lpstr>Calibri Light</vt:lpstr>
      <vt:lpstr>Times New Roman</vt:lpstr>
      <vt:lpstr>Office 테마</vt:lpstr>
      <vt:lpstr>Imag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대령</dc:creator>
  <cp:lastModifiedBy>Windows User</cp:lastModifiedBy>
  <cp:revision>225</cp:revision>
  <cp:lastPrinted>2014-07-29T08:24:50Z</cp:lastPrinted>
  <dcterms:created xsi:type="dcterms:W3CDTF">2014-05-21T07:45:37Z</dcterms:created>
  <dcterms:modified xsi:type="dcterms:W3CDTF">2016-01-30T02:33:49Z</dcterms:modified>
</cp:coreProperties>
</file>